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43"/>
  </p:normalViewPr>
  <p:slideViewPr>
    <p:cSldViewPr snapToGrid="0" snapToObjects="1" showGuides="1">
      <p:cViewPr varScale="1">
        <p:scale>
          <a:sx n="119" d="100"/>
          <a:sy n="119" d="100"/>
        </p:scale>
        <p:origin x="216" y="2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4948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7666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72518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67108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7593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ee object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78229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56463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7467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79214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89922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Klik om de tekststijl van het model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75293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Titelstijl van model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tekststijl van het model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5717F-9E54-CF40-A79C-0B05E78DCFEB}" type="datetimeFigureOut">
              <a:rPr lang="nl-NL" smtClean="0"/>
              <a:t>16-04-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E4C8C-F914-234B-A6D3-451EB8EF87E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63325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4089272" y="133275"/>
            <a:ext cx="4035669" cy="388711"/>
          </a:xfrm>
          <a:solidFill>
            <a:schemeClr val="bg1"/>
          </a:solidFill>
        </p:spPr>
        <p:txBody>
          <a:bodyPr anchor="t">
            <a:normAutofit fontScale="90000"/>
          </a:bodyPr>
          <a:lstStyle/>
          <a:p>
            <a:pPr algn="just"/>
            <a:r>
              <a:rPr lang="nl-NL" sz="1108" b="1" i="1" dirty="0">
                <a:latin typeface="Times New Roman" charset="0"/>
                <a:ea typeface="Times New Roman" charset="0"/>
                <a:cs typeface="Times New Roman" charset="0"/>
              </a:rPr>
              <a:t>Supplemental </a:t>
            </a:r>
            <a:r>
              <a:rPr lang="nl-NL" sz="1108" b="1" i="1" dirty="0" err="1">
                <a:latin typeface="Times New Roman" charset="0"/>
                <a:ea typeface="Times New Roman" charset="0"/>
                <a:cs typeface="Times New Roman" charset="0"/>
              </a:rPr>
              <a:t>Figure</a:t>
            </a:r>
            <a:r>
              <a:rPr lang="nl-NL" sz="1108" b="1" i="1" dirty="0">
                <a:latin typeface="Times New Roman" charset="0"/>
                <a:ea typeface="Times New Roman" charset="0"/>
                <a:cs typeface="Times New Roman" charset="0"/>
              </a:rPr>
              <a:t>: </a:t>
            </a:r>
            <a:r>
              <a:rPr lang="nl-NL" sz="1108" b="1" i="1" dirty="0" err="1">
                <a:latin typeface="Times New Roman" charset="0"/>
                <a:ea typeface="Times New Roman" charset="0"/>
                <a:cs typeface="Times New Roman" charset="0"/>
              </a:rPr>
              <a:t>Overview</a:t>
            </a:r>
            <a:r>
              <a:rPr lang="nl-NL" sz="1108" b="1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nl-NL" sz="1108" b="1" i="1" dirty="0" err="1">
                <a:latin typeface="Times New Roman" charset="0"/>
                <a:ea typeface="Times New Roman" charset="0"/>
                <a:cs typeface="Times New Roman" charset="0"/>
              </a:rPr>
              <a:t>numeric</a:t>
            </a:r>
            <a:r>
              <a:rPr lang="nl-NL" sz="1108" b="1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nl-NL" sz="1108" b="1" i="1" dirty="0" err="1">
                <a:latin typeface="Times New Roman" charset="0"/>
                <a:ea typeface="Times New Roman" charset="0"/>
                <a:cs typeface="Times New Roman" charset="0"/>
              </a:rPr>
              <a:t>HeartLogic</a:t>
            </a:r>
            <a:r>
              <a:rPr lang="nl-NL" sz="1108" b="1" i="1" dirty="0">
                <a:latin typeface="Times New Roman" charset="0"/>
                <a:ea typeface="Times New Roman" charset="0"/>
                <a:cs typeface="Times New Roman" charset="0"/>
              </a:rPr>
              <a:t> parameters </a:t>
            </a:r>
            <a:r>
              <a:rPr lang="nl-NL" sz="1108" b="1" i="1" dirty="0" err="1">
                <a:latin typeface="Times New Roman" charset="0"/>
                <a:ea typeface="Times New Roman" charset="0"/>
                <a:cs typeface="Times New Roman" charset="0"/>
              </a:rPr>
              <a:t>and</a:t>
            </a:r>
            <a:r>
              <a:rPr lang="nl-NL" sz="1108" b="1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nl-NL" sz="1108" b="1" i="1" dirty="0" err="1">
                <a:latin typeface="Times New Roman" charset="0"/>
                <a:ea typeface="Times New Roman" charset="0"/>
                <a:cs typeface="Times New Roman" charset="0"/>
              </a:rPr>
              <a:t>contributing</a:t>
            </a:r>
            <a:r>
              <a:rPr lang="nl-NL" sz="1108" b="1" i="1" dirty="0">
                <a:latin typeface="Times New Roman" charset="0"/>
                <a:ea typeface="Times New Roman" charset="0"/>
                <a:cs typeface="Times New Roman" charset="0"/>
              </a:rPr>
              <a:t> parameters.</a:t>
            </a:r>
            <a:endParaRPr lang="nl-NL" sz="1108" b="1" i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3" name="Afbeelding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0846" y="506027"/>
            <a:ext cx="3952800" cy="2135787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3" name="Afbeelding 2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021" y="2557108"/>
            <a:ext cx="3940426" cy="2088554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4" name="Afbeelding 2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9160"/>
          <a:stretch/>
        </p:blipFill>
        <p:spPr>
          <a:xfrm>
            <a:off x="4120847" y="4602260"/>
            <a:ext cx="1217519" cy="2121155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25" name="Afbeelding 2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878"/>
          <a:stretch/>
        </p:blipFill>
        <p:spPr>
          <a:xfrm>
            <a:off x="5338365" y="4602260"/>
            <a:ext cx="952279" cy="2121155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26" name="Rechthoek 25"/>
          <p:cNvSpPr/>
          <p:nvPr/>
        </p:nvSpPr>
        <p:spPr>
          <a:xfrm>
            <a:off x="5486525" y="754268"/>
            <a:ext cx="2551454" cy="88743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1246" i="1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7" name="Rechthoek 26"/>
          <p:cNvSpPr/>
          <p:nvPr/>
        </p:nvSpPr>
        <p:spPr>
          <a:xfrm>
            <a:off x="5486525" y="2805801"/>
            <a:ext cx="1706082" cy="77873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1246" i="1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8" name="Rechthoek 27"/>
          <p:cNvSpPr/>
          <p:nvPr/>
        </p:nvSpPr>
        <p:spPr>
          <a:xfrm>
            <a:off x="7215055" y="2805801"/>
            <a:ext cx="813944" cy="778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1246" i="1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9" name="Rechthoek 28"/>
          <p:cNvSpPr/>
          <p:nvPr/>
        </p:nvSpPr>
        <p:spPr>
          <a:xfrm>
            <a:off x="5383262" y="4865019"/>
            <a:ext cx="874554" cy="781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1246" i="1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1" name="Rechte verbindingslijn 10"/>
          <p:cNvCxnSpPr/>
          <p:nvPr/>
        </p:nvCxnSpPr>
        <p:spPr>
          <a:xfrm flipH="1" flipV="1">
            <a:off x="7205964" y="2898140"/>
            <a:ext cx="705" cy="405265"/>
          </a:xfrm>
          <a:prstGeom prst="line">
            <a:avLst/>
          </a:prstGeom>
          <a:ln w="38100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kstvak 3"/>
          <p:cNvSpPr txBox="1"/>
          <p:nvPr/>
        </p:nvSpPr>
        <p:spPr>
          <a:xfrm>
            <a:off x="6473720" y="3305756"/>
            <a:ext cx="1524776" cy="20960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nl-NL" sz="762" i="1" dirty="0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First </a:t>
            </a:r>
            <a:r>
              <a:rPr lang="nl-NL" sz="762" i="1" dirty="0" err="1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increase</a:t>
            </a:r>
            <a:r>
              <a:rPr lang="nl-NL" sz="762" i="1" dirty="0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 HL </a:t>
            </a:r>
            <a:r>
              <a:rPr lang="nl-NL" sz="762" i="1" dirty="0" err="1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above</a:t>
            </a:r>
            <a:r>
              <a:rPr lang="nl-NL" sz="762" i="1" dirty="0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nl-NL" sz="762" i="1" dirty="0" err="1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threshold</a:t>
            </a:r>
            <a:endParaRPr lang="nl-NL" sz="762" i="1" dirty="0">
              <a:solidFill>
                <a:srgbClr val="FF0000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13" name="Rechte verbindingslijn 12"/>
          <p:cNvCxnSpPr/>
          <p:nvPr/>
        </p:nvCxnSpPr>
        <p:spPr>
          <a:xfrm flipH="1" flipV="1">
            <a:off x="6183728" y="4959872"/>
            <a:ext cx="705" cy="405265"/>
          </a:xfrm>
          <a:prstGeom prst="line">
            <a:avLst/>
          </a:prstGeom>
          <a:ln w="38100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kstvak 13"/>
          <p:cNvSpPr txBox="1"/>
          <p:nvPr/>
        </p:nvSpPr>
        <p:spPr>
          <a:xfrm>
            <a:off x="6169238" y="5365091"/>
            <a:ext cx="832279" cy="20960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nl-NL" sz="762" i="1" dirty="0" err="1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Admission</a:t>
            </a:r>
            <a:r>
              <a:rPr lang="nl-NL" sz="762" i="1" dirty="0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 at ER</a:t>
            </a:r>
            <a:endParaRPr lang="nl-NL" sz="762" i="1" dirty="0">
              <a:solidFill>
                <a:srgbClr val="FF0000"/>
              </a:solidFill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8913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</Words>
  <Application>Microsoft Macintosh PowerPoint</Application>
  <PresentationFormat>Breedbeeld</PresentationFormat>
  <Paragraphs>3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hema</vt:lpstr>
      <vt:lpstr>Supplemental Figure: Overview numeric HeartLogic parameters and contributing parameters.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: Overview numeric HeartLogic parameters and contributing parameters.</dc:title>
  <dc:creator>Heggermont Ward</dc:creator>
  <cp:lastModifiedBy>Heggermont Ward</cp:lastModifiedBy>
  <cp:revision>1</cp:revision>
  <dcterms:created xsi:type="dcterms:W3CDTF">2020-04-16T18:59:30Z</dcterms:created>
  <dcterms:modified xsi:type="dcterms:W3CDTF">2020-04-16T19:01:24Z</dcterms:modified>
</cp:coreProperties>
</file>